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9144000" cy="6858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8056" autoAdjust="0"/>
    <p:restoredTop sz="91554" autoAdjust="0"/>
  </p:normalViewPr>
  <p:slideViewPr>
    <p:cSldViewPr snapToGrid="0">
      <p:cViewPr>
        <p:scale>
          <a:sx n="100" d="100"/>
          <a:sy n="100" d="100"/>
        </p:scale>
        <p:origin x="672" y="522"/>
      </p:cViewPr>
      <p:guideLst/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7" d="100"/>
          <a:sy n="77" d="100"/>
        </p:scale>
        <p:origin x="1554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61F5EE-204C-44EF-9CDE-B6A9D29DBF00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3013"/>
            <a:ext cx="4471987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3307"/>
            <a:ext cx="544449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939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F83BF9-757E-4CFF-BD36-EDFC15CB57F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86110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F83BF9-757E-4CFF-BD36-EDFC15CB57F6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85939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90720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34210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52482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8248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51773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25420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54098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60997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90089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2456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66061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B0896-A179-417A-8753-8EA2C53D40F1}" type="datetimeFigureOut">
              <a:rPr kumimoji="1" lang="ja-JP" altLang="en-US" smtClean="0"/>
              <a:t>2020/1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439D1-3F60-43FC-8FED-E92BDE0D768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9504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/>
          <p:nvPr/>
        </p:nvSpPr>
        <p:spPr>
          <a:xfrm>
            <a:off x="40140" y="6364525"/>
            <a:ext cx="87941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/>
                <a:cs typeface="Arial"/>
              </a:rPr>
              <a:t>Supplementary</a:t>
            </a:r>
            <a:r>
              <a:rPr kumimoji="1" lang="ja-JP" altLang="en-US" sz="2400" dirty="0" smtClean="0">
                <a:latin typeface="Arial"/>
                <a:cs typeface="Arial"/>
              </a:rPr>
              <a:t> </a:t>
            </a:r>
            <a:r>
              <a:rPr kumimoji="1" lang="en-US" altLang="ja-JP" sz="2400" dirty="0" smtClean="0">
                <a:latin typeface="Arial"/>
                <a:cs typeface="Arial"/>
              </a:rPr>
              <a:t>Fig</a:t>
            </a:r>
            <a:r>
              <a:rPr lang="en-US" altLang="ja-JP" sz="2400" dirty="0" smtClean="0">
                <a:latin typeface="Arial"/>
                <a:cs typeface="Arial"/>
              </a:rPr>
              <a:t>ure</a:t>
            </a:r>
            <a:r>
              <a:rPr kumimoji="1" lang="en-US" altLang="ja-JP" sz="2400" dirty="0" smtClean="0">
                <a:latin typeface="Arial"/>
                <a:cs typeface="Arial"/>
              </a:rPr>
              <a:t> </a:t>
            </a:r>
            <a:r>
              <a:rPr kumimoji="1" lang="en-US" altLang="ja-JP" sz="2400" dirty="0">
                <a:latin typeface="Arial"/>
                <a:cs typeface="Arial"/>
              </a:rPr>
              <a:t>1.</a:t>
            </a:r>
            <a:endParaRPr kumimoji="1" lang="ja-JP" altLang="en-US" sz="2400" dirty="0">
              <a:latin typeface="Arial"/>
              <a:cs typeface="Arial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DF0791B-6278-48C6-8465-230ECFE399B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78" t="1" r="21553" b="-717"/>
          <a:stretch/>
        </p:blipFill>
        <p:spPr>
          <a:xfrm>
            <a:off x="2931385" y="3359807"/>
            <a:ext cx="2377441" cy="130758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17F9834-6805-438B-9ABC-6DA4EDFBA6C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76" t="705" r="17452" b="-705"/>
          <a:stretch/>
        </p:blipFill>
        <p:spPr>
          <a:xfrm>
            <a:off x="2894809" y="1461691"/>
            <a:ext cx="2414017" cy="172819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3437C0F-6F92-4F16-8D7C-C565E18059B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83" t="-1601" r="18299"/>
          <a:stretch/>
        </p:blipFill>
        <p:spPr>
          <a:xfrm>
            <a:off x="2931387" y="4838083"/>
            <a:ext cx="2499360" cy="663507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5349317" y="1493327"/>
            <a:ext cx="1170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←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FPα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49317" y="2635953"/>
            <a:ext cx="1170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←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FPβ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423150" y="4936998"/>
            <a:ext cx="1369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←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VLCAD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432482" y="4153284"/>
            <a:ext cx="1170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←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Fβ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DA3AE2E-C737-42D8-864F-CBC6CF452F22}"/>
              </a:ext>
            </a:extLst>
          </p:cNvPr>
          <p:cNvSpPr txBox="1"/>
          <p:nvPr/>
        </p:nvSpPr>
        <p:spPr>
          <a:xfrm>
            <a:off x="5432482" y="3680635"/>
            <a:ext cx="1170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←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Fα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 rot="19876813">
            <a:off x="3534937" y="870314"/>
            <a:ext cx="15327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FP-α</a:t>
            </a:r>
            <a:r>
              <a:rPr lang="ja-JP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ficiency</a:t>
            </a:r>
          </a:p>
        </p:txBody>
      </p:sp>
      <p:sp>
        <p:nvSpPr>
          <p:cNvPr id="12" name="正方形/長方形 11"/>
          <p:cNvSpPr/>
          <p:nvPr/>
        </p:nvSpPr>
        <p:spPr>
          <a:xfrm rot="19876813">
            <a:off x="2854600" y="984910"/>
            <a:ext cx="7425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 rot="19876813">
            <a:off x="4450279" y="860777"/>
            <a:ext cx="15327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TF-α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ficiency</a:t>
            </a:r>
          </a:p>
        </p:txBody>
      </p:sp>
    </p:spTree>
    <p:extLst>
      <p:ext uri="{BB962C8B-B14F-4D97-AF65-F5344CB8AC3E}">
        <p14:creationId xmlns:p14="http://schemas.microsoft.com/office/powerpoint/2010/main" val="508505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5</TotalTime>
  <Words>20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Nakama</dc:creator>
  <cp:lastModifiedBy>Author</cp:lastModifiedBy>
  <cp:revision>345</cp:revision>
  <cp:lastPrinted>2020-01-08T01:33:41Z</cp:lastPrinted>
  <dcterms:created xsi:type="dcterms:W3CDTF">2019-01-04T08:38:38Z</dcterms:created>
  <dcterms:modified xsi:type="dcterms:W3CDTF">2020-01-19T04:28:14Z</dcterms:modified>
</cp:coreProperties>
</file>